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047533-9C11-40AC-B4AA-9537A5B8B6F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303937-5E51-4580-9F7F-978C0E3E70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274C38-D8B9-4BAA-9904-5C4987B3FFF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304B67-0D49-41C2-87C1-DCD03FBB43F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DB2CC8-F0DF-4FB0-BB74-D9411C2C2A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786CAB-B728-4FC0-8805-FF8FD96F94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63DB58-21C9-4609-B834-DC14C0F0DA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511D1E-2853-40EB-82D8-699673FE14E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C30A9C-D675-4499-8CE2-6723F002FE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F1072E-85AE-4CEC-AA6F-D989EA8935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9C1845-1A62-4D00-B681-EAD795BA15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2A9769-9876-47C5-8CFB-BA69A41E68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8FD4D20-37B0-4BFE-99E3-27F58C70EF8B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e 3"/>
          <p:cNvGrpSpPr/>
          <p:nvPr/>
        </p:nvGrpSpPr>
        <p:grpSpPr>
          <a:xfrm>
            <a:off x="71280" y="1460520"/>
            <a:ext cx="6624720" cy="5202360"/>
            <a:chOff x="71280" y="1460520"/>
            <a:chExt cx="6624720" cy="5202360"/>
          </a:xfrm>
        </p:grpSpPr>
        <p:pic>
          <p:nvPicPr>
            <p:cNvPr id="42" name="Picture 2" descr=""/>
            <p:cNvPicPr/>
            <p:nvPr/>
          </p:nvPicPr>
          <p:blipFill>
            <a:blip r:embed="rId1"/>
            <a:stretch/>
          </p:blipFill>
          <p:spPr>
            <a:xfrm>
              <a:off x="503280" y="1460520"/>
              <a:ext cx="6192720" cy="3134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3" descr=""/>
            <p:cNvPicPr/>
            <p:nvPr/>
          </p:nvPicPr>
          <p:blipFill>
            <a:blip r:embed="rId2"/>
            <a:stretch/>
          </p:blipFill>
          <p:spPr>
            <a:xfrm>
              <a:off x="503280" y="4621680"/>
              <a:ext cx="6192720" cy="2041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ZoneTexte 6"/>
            <p:cNvSpPr/>
            <p:nvPr/>
          </p:nvSpPr>
          <p:spPr>
            <a:xfrm>
              <a:off x="71280" y="1511280"/>
              <a:ext cx="919440" cy="1008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fg5 </a:t>
              </a:r>
              <a:r>
                <a:rPr b="0" i="1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. cerevisiae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cw1 </a:t>
              </a:r>
              <a:r>
                <a:rPr b="0" i="1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. cerevisiae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fg2 AFUA_2G0068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fg5 AFUA_4G0062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fg4 AFUA_3G007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fg3 AFUA_3G0034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fg7 AFUA_4G0272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fg1 AFUA_1G0173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fg6 AFUA_3G0204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5" name="Connecteur droit 15"/>
          <p:cNvSpPr/>
          <p:nvPr/>
        </p:nvSpPr>
        <p:spPr>
          <a:xfrm>
            <a:off x="4680000" y="6659640"/>
            <a:ext cx="1224000" cy="0"/>
          </a:xfrm>
          <a:prstGeom prst="line">
            <a:avLst/>
          </a:prstGeom>
          <a:ln w="19080">
            <a:solidFill>
              <a:srgbClr val="000000"/>
            </a:solidFill>
            <a:prstDash val="lgDashDot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Connecteur droit 17"/>
          <p:cNvSpPr/>
          <p:nvPr/>
        </p:nvSpPr>
        <p:spPr>
          <a:xfrm>
            <a:off x="1079640" y="4572000"/>
            <a:ext cx="5329080" cy="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Connecteur droit 23"/>
          <p:cNvSpPr/>
          <p:nvPr/>
        </p:nvSpPr>
        <p:spPr>
          <a:xfrm>
            <a:off x="1079640" y="5651640"/>
            <a:ext cx="5329080" cy="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Connecteur droit 24"/>
          <p:cNvSpPr/>
          <p:nvPr/>
        </p:nvSpPr>
        <p:spPr>
          <a:xfrm flipV="1">
            <a:off x="1079640" y="6732720"/>
            <a:ext cx="1800000" cy="792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Connecteur droit 33"/>
          <p:cNvSpPr/>
          <p:nvPr/>
        </p:nvSpPr>
        <p:spPr>
          <a:xfrm>
            <a:off x="2232000" y="3564000"/>
            <a:ext cx="4176720" cy="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Groupe 39"/>
          <p:cNvGrpSpPr/>
          <p:nvPr/>
        </p:nvGrpSpPr>
        <p:grpSpPr>
          <a:xfrm>
            <a:off x="1728720" y="6997680"/>
            <a:ext cx="1813320" cy="246240"/>
            <a:chOff x="1728720" y="6997680"/>
            <a:chExt cx="1813320" cy="246240"/>
          </a:xfrm>
        </p:grpSpPr>
        <p:sp>
          <p:nvSpPr>
            <p:cNvPr id="51" name="ZoneTexte 12"/>
            <p:cNvSpPr/>
            <p:nvPr/>
          </p:nvSpPr>
          <p:spPr>
            <a:xfrm>
              <a:off x="2094840" y="6997680"/>
              <a:ext cx="1447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Calibri"/>
                </a:rPr>
                <a:t>GPI anchoring sequenc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Connecteur droit 36"/>
            <p:cNvSpPr/>
            <p:nvPr/>
          </p:nvSpPr>
          <p:spPr>
            <a:xfrm>
              <a:off x="1728720" y="7142400"/>
              <a:ext cx="431640" cy="0"/>
            </a:xfrm>
            <a:prstGeom prst="line">
              <a:avLst/>
            </a:prstGeom>
            <a:ln w="19080">
              <a:solidFill>
                <a:srgbClr val="000000"/>
              </a:solidFill>
              <a:prstDash val="lgDashDot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3" name="Groupe 52"/>
          <p:cNvGrpSpPr/>
          <p:nvPr/>
        </p:nvGrpSpPr>
        <p:grpSpPr>
          <a:xfrm>
            <a:off x="287280" y="7020000"/>
            <a:ext cx="1266840" cy="246240"/>
            <a:chOff x="287280" y="7020000"/>
            <a:chExt cx="1266840" cy="246240"/>
          </a:xfrm>
        </p:grpSpPr>
        <p:sp>
          <p:nvSpPr>
            <p:cNvPr id="54" name="Connecteur droit 50"/>
            <p:cNvSpPr/>
            <p:nvPr/>
          </p:nvSpPr>
          <p:spPr>
            <a:xfrm>
              <a:off x="287280" y="7140600"/>
              <a:ext cx="431640" cy="0"/>
            </a:xfrm>
            <a:prstGeom prst="line">
              <a:avLst/>
            </a:prstGeom>
            <a:ln w="19080">
              <a:solidFill>
                <a:srgbClr val="0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ZoneTexte 51"/>
            <p:cNvSpPr/>
            <p:nvPr/>
          </p:nvSpPr>
          <p:spPr>
            <a:xfrm>
              <a:off x="654120" y="7020000"/>
              <a:ext cx="90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GH76 doma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6" name="Connecteur droit 59"/>
          <p:cNvSpPr/>
          <p:nvPr/>
        </p:nvSpPr>
        <p:spPr>
          <a:xfrm>
            <a:off x="3816360" y="7143840"/>
            <a:ext cx="431640" cy="0"/>
          </a:xfrm>
          <a:prstGeom prst="line">
            <a:avLst/>
          </a:prstGeom>
          <a:ln w="1908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ZoneTexte 60"/>
          <p:cNvSpPr/>
          <p:nvPr/>
        </p:nvSpPr>
        <p:spPr>
          <a:xfrm>
            <a:off x="4321080" y="699444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Signal peptid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Connecteur droit 61"/>
          <p:cNvSpPr/>
          <p:nvPr/>
        </p:nvSpPr>
        <p:spPr>
          <a:xfrm>
            <a:off x="3816360" y="2411280"/>
            <a:ext cx="2663640" cy="0"/>
          </a:xfrm>
          <a:prstGeom prst="line">
            <a:avLst/>
          </a:prstGeom>
          <a:ln w="1908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Connecteur droit 63"/>
          <p:cNvSpPr/>
          <p:nvPr/>
        </p:nvSpPr>
        <p:spPr>
          <a:xfrm>
            <a:off x="1079640" y="3564000"/>
            <a:ext cx="720720" cy="0"/>
          </a:xfrm>
          <a:prstGeom prst="line">
            <a:avLst/>
          </a:prstGeom>
          <a:ln w="1908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ZoneTexte 26"/>
          <p:cNvSpPr/>
          <p:nvPr/>
        </p:nvSpPr>
        <p:spPr>
          <a:xfrm>
            <a:off x="74520" y="3618000"/>
            <a:ext cx="919080" cy="1008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5 </a:t>
            </a:r>
            <a:r>
              <a:rPr b="0" i="1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 cerevisia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cw1 </a:t>
            </a:r>
            <a:r>
              <a:rPr b="0" i="1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 cerevisia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2 AFUA_2G0068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5 AFUA_4G0062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4 AFUA_3G007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3 AFUA_3G0034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7 AFUA_4G0272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1 AFUA_1G0173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6 AFUA_3G0204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ZoneTexte 27"/>
          <p:cNvSpPr/>
          <p:nvPr/>
        </p:nvSpPr>
        <p:spPr>
          <a:xfrm>
            <a:off x="68400" y="2581200"/>
            <a:ext cx="919080" cy="1008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5 </a:t>
            </a:r>
            <a:r>
              <a:rPr b="0" i="1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 cerevisia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cw1 </a:t>
            </a:r>
            <a:r>
              <a:rPr b="0" i="1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 cerevisia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2 AFUA_2G0068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5 AFUA_4G0062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4 AFUA_3G007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3 AFUA_3G0034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7 AFUA_4G0272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1 AFUA_1G0173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6 AFUA_3G0204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ZoneTexte 28"/>
          <p:cNvSpPr/>
          <p:nvPr/>
        </p:nvSpPr>
        <p:spPr>
          <a:xfrm>
            <a:off x="74520" y="4675320"/>
            <a:ext cx="919080" cy="1008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5 </a:t>
            </a:r>
            <a:r>
              <a:rPr b="0" i="1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 cerevisia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cw1 </a:t>
            </a:r>
            <a:r>
              <a:rPr b="0" i="1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 cerevisia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2 AFUA_2G0068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5 AFUA_4G0062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4 AFUA_3G007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3 AFUA_3G0034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7 AFUA_4G0272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1 AFUA_1G0173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6 AFUA_3G0204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ZoneTexte 29"/>
          <p:cNvSpPr/>
          <p:nvPr/>
        </p:nvSpPr>
        <p:spPr>
          <a:xfrm>
            <a:off x="73080" y="5716440"/>
            <a:ext cx="919080" cy="1008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5 </a:t>
            </a:r>
            <a:r>
              <a:rPr b="0" i="1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 cerevisia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cw1 </a:t>
            </a:r>
            <a:r>
              <a:rPr b="0" i="1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 cerevisia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2 AFUA_2G0068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5 AFUA_4G0062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4 AFUA_3G007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3 AFUA_3G0034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7 AFUA_4G0272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1 AFUA_1G0173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fg6 AFUA_3G0204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1"/>
          <p:cNvSpPr/>
          <p:nvPr/>
        </p:nvSpPr>
        <p:spPr>
          <a:xfrm>
            <a:off x="74520" y="7596360"/>
            <a:ext cx="6507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2-08T14:00:27Z</dcterms:created>
  <dc:creator>anne jp</dc:creator>
  <dc:description/>
  <dc:language>en-US</dc:language>
  <cp:lastModifiedBy>Utilisateur Microsoft Office</cp:lastModifiedBy>
  <cp:lastPrinted>2014-07-09T07:56:18Z</cp:lastPrinted>
  <dcterms:modified xsi:type="dcterms:W3CDTF">2019-06-24T09:58:12Z</dcterms:modified>
  <cp:revision>269</cp:revision>
  <dc:subject/>
  <dc:title>Présentation PowerPoint</dc:title>
</cp:coreProperties>
</file>